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7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443E266D-FEE6-B582-38F6-742DD249AA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07165F2C-2F6A-B483-4231-B3532F8485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05CDA315-FDC9-3E21-CDA9-BE09CD3816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00D9-769D-4EFC-A568-8FE4E20BACBC}" type="datetimeFigureOut">
              <a:rPr lang="hu-HU" smtClean="0"/>
              <a:t>2023. 10. 2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8AC39E9B-B664-3F4B-3B61-5589DC219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50F465AC-3946-4331-2261-CF7659A6DF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E943D-F2C1-4338-874A-DAD4FDAD1D8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83182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68F99DA3-3754-A963-BDC6-7DFCC35760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84F226D3-94FC-18B8-0898-18AAF23155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317D0170-29BF-22DD-0377-0C3C27AF11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00D9-769D-4EFC-A568-8FE4E20BACBC}" type="datetimeFigureOut">
              <a:rPr lang="hu-HU" smtClean="0"/>
              <a:t>2023. 10. 2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5BFFE05E-8609-1588-273A-91166C9AF4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C7C8FC54-34A2-2213-ECF7-270FEF9C5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E943D-F2C1-4338-874A-DAD4FDAD1D8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493692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5A6F3B00-CAF9-D813-A533-6AAE38885D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63D052E6-5C4D-2003-130F-3DE7507208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0C0A4EDE-22AA-37F4-8F11-C8F8B61A30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00D9-769D-4EFC-A568-8FE4E20BACBC}" type="datetimeFigureOut">
              <a:rPr lang="hu-HU" smtClean="0"/>
              <a:t>2023. 10. 2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BE14B167-781D-C3D1-C5CB-0DFFF9E22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76A41F18-3578-EA68-6181-3777EF99A2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E943D-F2C1-4338-874A-DAD4FDAD1D8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9298172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97E71BB6-966F-702F-0095-8F182B9E63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F49A1238-1231-8D6B-AFE4-3299D2ECD4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6E39D69B-CB35-A4D5-7F4B-75B06D0493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00D9-769D-4EFC-A568-8FE4E20BACBC}" type="datetimeFigureOut">
              <a:rPr lang="hu-HU" smtClean="0"/>
              <a:t>2023. 10. 2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608A0B66-90FF-5202-212A-BE7B9B5CF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C9F8E2DC-C689-CE7C-34CD-CA11C69E9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E943D-F2C1-4338-874A-DAD4FDAD1D8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65716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80BA2F5-0D8D-0E4C-DA49-10A624B262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4E370C63-AA3D-95DE-489A-3F6385F728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4010C853-B0E5-3079-9C31-E942F75FE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00D9-769D-4EFC-A568-8FE4E20BACBC}" type="datetimeFigureOut">
              <a:rPr lang="hu-HU" smtClean="0"/>
              <a:t>2023. 10. 2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2649E880-F1D1-D886-45A0-C906587F10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20F2F3D6-AE7C-EE9D-9809-E09F46A820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E943D-F2C1-4338-874A-DAD4FDAD1D8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81962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CCDA94B-D28D-1B44-201D-BA0A67BE7B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58DD483F-B5C4-5E07-A49E-3876493E93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5B9C07E2-A1D2-B487-81A4-81F62062C9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658583A3-366D-6716-24CE-65295DD93D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00D9-769D-4EFC-A568-8FE4E20BACBC}" type="datetimeFigureOut">
              <a:rPr lang="hu-HU" smtClean="0"/>
              <a:t>2023. 10. 2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21549822-418C-723D-1C35-9BFEC9734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0039065D-E1DB-F98B-EF1E-618B3B361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E943D-F2C1-4338-874A-DAD4FDAD1D8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023659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AA1AF6F1-E8FB-A96C-2CEB-4BAAD0201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F1FD3C11-164C-F9D5-5DF7-A46E4CEC82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57DA9F60-EFB3-FADE-5DC5-D0C6AA390D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58B0B450-840B-65BF-316D-8314F433E4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8A945E12-5C5A-EF33-A23E-24E1E609D2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83217D30-C1BA-AA55-485C-69AE046128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00D9-769D-4EFC-A568-8FE4E20BACBC}" type="datetimeFigureOut">
              <a:rPr lang="hu-HU" smtClean="0"/>
              <a:t>2023. 10. 29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4C62CFDF-83DB-CF1A-4859-334CD9A092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73C71481-7F13-7EF4-2011-991B7A1C82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E943D-F2C1-4338-874A-DAD4FDAD1D8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96947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41A85F9-066A-AA29-77BB-2E4F1744F9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42BC1F89-C077-EF8D-116A-4D642FDA93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00D9-769D-4EFC-A568-8FE4E20BACBC}" type="datetimeFigureOut">
              <a:rPr lang="hu-HU" smtClean="0"/>
              <a:t>2023. 10. 29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A3DF4EB9-D5AA-AE59-D828-374F1667D4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63CACDBF-230C-1F73-852E-7891C2D9F9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E943D-F2C1-4338-874A-DAD4FDAD1D8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171072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54636769-5F9B-0A57-5B1C-5AA2CB0F65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00D9-769D-4EFC-A568-8FE4E20BACBC}" type="datetimeFigureOut">
              <a:rPr lang="hu-HU" smtClean="0"/>
              <a:t>2023. 10. 29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B1A0ADB5-5ACE-0C9C-074A-A71F1B8A6C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72D273B0-490A-CB29-F2AA-3E6EEF9C6E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E943D-F2C1-4338-874A-DAD4FDAD1D8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93093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BA487AB-0D9E-E115-329A-E3B3CC8A09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B907A850-3F8C-8CED-104B-5C0280179B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3B58F8DA-BA72-8460-DEF1-58E3374739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644B1278-E010-92C3-2FE3-D3C62FD1CE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00D9-769D-4EFC-A568-8FE4E20BACBC}" type="datetimeFigureOut">
              <a:rPr lang="hu-HU" smtClean="0"/>
              <a:t>2023. 10. 2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6663F7F5-516E-1101-23B5-2AE5DEF059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06FF4B6B-89AB-F7F4-A56E-52CFA6ABB5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E943D-F2C1-4338-874A-DAD4FDAD1D8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904531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C6A52C5A-5B1D-8A46-484D-50C9B05F71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31A42DA6-4350-710A-019E-E33B47C159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49765348-6BC8-AF8F-46BC-4826AEA610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B1D206BB-489E-7212-17E5-8830EF916A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400D9-769D-4EFC-A568-8FE4E20BACBC}" type="datetimeFigureOut">
              <a:rPr lang="hu-HU" smtClean="0"/>
              <a:t>2023. 10. 2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20335D80-20C6-2100-7C7B-72351FBCCA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9A572B72-A7B3-7062-CE2D-BE8E7497E6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E943D-F2C1-4338-874A-DAD4FDAD1D8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822145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77B9B221-F297-325C-0A38-319F8C04C9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CA0727F1-BF1C-AFC5-861E-D907A3A6B6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CF908268-92B5-BCF9-AB38-E37ED2199D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8400D9-769D-4EFC-A568-8FE4E20BACBC}" type="datetimeFigureOut">
              <a:rPr lang="hu-HU" smtClean="0"/>
              <a:t>2023. 10. 2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4BF50737-1700-EFD9-EDCD-F7A251A0AC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EDB3BA31-AE31-308F-1738-CDB840E065D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6E943D-F2C1-4338-874A-DAD4FDAD1D85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883231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Kép 4">
            <a:extLst>
              <a:ext uri="{FF2B5EF4-FFF2-40B4-BE49-F238E27FC236}">
                <a16:creationId xmlns:a16="http://schemas.microsoft.com/office/drawing/2014/main" id="{6605D76E-5FFE-A09B-0070-117C075ADA5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4471"/>
          <a:stretch/>
        </p:blipFill>
        <p:spPr>
          <a:xfrm>
            <a:off x="5274448" y="155315"/>
            <a:ext cx="5819814" cy="4282735"/>
          </a:xfrm>
          <a:prstGeom prst="rect">
            <a:avLst/>
          </a:prstGeom>
        </p:spPr>
      </p:pic>
      <p:pic>
        <p:nvPicPr>
          <p:cNvPr id="6" name="Kép 5">
            <a:extLst>
              <a:ext uri="{FF2B5EF4-FFF2-40B4-BE49-F238E27FC236}">
                <a16:creationId xmlns:a16="http://schemas.microsoft.com/office/drawing/2014/main" id="{8507DC09-2C07-857E-3D61-82F44EBB3A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6696" y="354292"/>
            <a:ext cx="3403191" cy="2708503"/>
          </a:xfrm>
          <a:prstGeom prst="rect">
            <a:avLst/>
          </a:prstGeom>
        </p:spPr>
      </p:pic>
      <p:pic>
        <p:nvPicPr>
          <p:cNvPr id="8" name="Kép 7">
            <a:extLst>
              <a:ext uri="{FF2B5EF4-FFF2-40B4-BE49-F238E27FC236}">
                <a16:creationId xmlns:a16="http://schemas.microsoft.com/office/drawing/2014/main" id="{05173D67-E8A8-288D-7958-502D897F600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309253" y="449064"/>
            <a:ext cx="857143" cy="1847619"/>
          </a:xfrm>
          <a:prstGeom prst="rect">
            <a:avLst/>
          </a:prstGeom>
        </p:spPr>
      </p:pic>
      <p:sp>
        <p:nvSpPr>
          <p:cNvPr id="9" name="Szövegdoboz 8">
            <a:extLst>
              <a:ext uri="{FF2B5EF4-FFF2-40B4-BE49-F238E27FC236}">
                <a16:creationId xmlns:a16="http://schemas.microsoft.com/office/drawing/2014/main" id="{C35288E8-7630-1524-F343-F99EC8EC6DF3}"/>
              </a:ext>
            </a:extLst>
          </p:cNvPr>
          <p:cNvSpPr txBox="1"/>
          <p:nvPr/>
        </p:nvSpPr>
        <p:spPr>
          <a:xfrm>
            <a:off x="149811" y="237829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400"/>
              <a:t>A</a:t>
            </a:r>
          </a:p>
        </p:txBody>
      </p:sp>
      <p:sp>
        <p:nvSpPr>
          <p:cNvPr id="10" name="Szövegdoboz 9">
            <a:extLst>
              <a:ext uri="{FF2B5EF4-FFF2-40B4-BE49-F238E27FC236}">
                <a16:creationId xmlns:a16="http://schemas.microsoft.com/office/drawing/2014/main" id="{4D1BDFEF-38CD-13B0-4DA9-0EE14DB008A8}"/>
              </a:ext>
            </a:extLst>
          </p:cNvPr>
          <p:cNvSpPr txBox="1"/>
          <p:nvPr/>
        </p:nvSpPr>
        <p:spPr>
          <a:xfrm>
            <a:off x="4781705" y="218232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400"/>
              <a:t>B</a:t>
            </a:r>
          </a:p>
        </p:txBody>
      </p:sp>
      <p:sp>
        <p:nvSpPr>
          <p:cNvPr id="12" name="Szövegdoboz 11">
            <a:extLst>
              <a:ext uri="{FF2B5EF4-FFF2-40B4-BE49-F238E27FC236}">
                <a16:creationId xmlns:a16="http://schemas.microsoft.com/office/drawing/2014/main" id="{789FA7EF-3CAA-769C-03A9-4827581D4697}"/>
              </a:ext>
            </a:extLst>
          </p:cNvPr>
          <p:cNvSpPr txBox="1"/>
          <p:nvPr/>
        </p:nvSpPr>
        <p:spPr>
          <a:xfrm>
            <a:off x="4545367" y="4827665"/>
            <a:ext cx="7277977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hu-HU" sz="1400"/>
              <a:t>Supplementary Figure 1. A. Amino acid sequence identity of five </a:t>
            </a:r>
            <a:r>
              <a:rPr lang="hu-HU" sz="1400" i="1"/>
              <a:t>Arabidopsis thaliana </a:t>
            </a:r>
            <a:r>
              <a:rPr lang="hu-HU" sz="1400"/>
              <a:t>and fourteen </a:t>
            </a:r>
            <a:r>
              <a:rPr lang="hu-HU" sz="1400" i="1"/>
              <a:t>Nicotiana tabacum </a:t>
            </a:r>
            <a:r>
              <a:rPr lang="hu-HU" sz="1400"/>
              <a:t>POLYAMINE OXIDASE (PAO) proteins based on sequence alignemnet performed by ClustalW [39]. B. Comparison </a:t>
            </a:r>
            <a:r>
              <a:rPr lang="en-US" sz="1400"/>
              <a:t>of structural </a:t>
            </a:r>
            <a:r>
              <a:rPr lang="hu-HU" sz="1400"/>
              <a:t>motifs</a:t>
            </a:r>
            <a:r>
              <a:rPr lang="en-US" sz="1400"/>
              <a:t> </a:t>
            </a:r>
            <a:r>
              <a:rPr lang="hu-HU" sz="1400"/>
              <a:t>identified by the MEME motif discovery tool [37] </a:t>
            </a:r>
            <a:r>
              <a:rPr lang="en-US" sz="1400"/>
              <a:t>confirm</a:t>
            </a:r>
            <a:r>
              <a:rPr lang="hu-HU" sz="1400"/>
              <a:t>ing</a:t>
            </a:r>
            <a:r>
              <a:rPr lang="en-US" sz="1400"/>
              <a:t> the </a:t>
            </a:r>
            <a:r>
              <a:rPr lang="hu-HU" sz="1400"/>
              <a:t>annotation of the </a:t>
            </a:r>
            <a:r>
              <a:rPr lang="hu-HU" sz="1400" i="1"/>
              <a:t>N. tabacum </a:t>
            </a:r>
            <a:r>
              <a:rPr lang="hu-HU" sz="1400"/>
              <a:t>proteins based on their similarity to Arabidopsis PAOs. C. The C-terminal aminoacid sequence of </a:t>
            </a:r>
            <a:r>
              <a:rPr lang="hu-HU" sz="1400" i="1"/>
              <a:t>A. thaliana </a:t>
            </a:r>
            <a:r>
              <a:rPr lang="hu-HU" sz="1400"/>
              <a:t>and </a:t>
            </a:r>
            <a:r>
              <a:rPr lang="hu-HU" sz="1400" i="1"/>
              <a:t>N. tabacum </a:t>
            </a:r>
            <a:r>
              <a:rPr lang="hu-HU" sz="1400"/>
              <a:t>PAO proteins with the peroxisomal targeting signal </a:t>
            </a:r>
            <a:r>
              <a:rPr lang="pt-BR" sz="1400"/>
              <a:t>(S/A/C)(K/R/H)(L/M) </a:t>
            </a:r>
            <a:r>
              <a:rPr lang="hu-HU" sz="1400"/>
              <a:t>boxed by  red dashed lines.</a:t>
            </a:r>
          </a:p>
        </p:txBody>
      </p:sp>
      <p:sp>
        <p:nvSpPr>
          <p:cNvPr id="7" name="Szövegdoboz 6">
            <a:extLst>
              <a:ext uri="{FF2B5EF4-FFF2-40B4-BE49-F238E27FC236}">
                <a16:creationId xmlns:a16="http://schemas.microsoft.com/office/drawing/2014/main" id="{66FC72E7-A790-839B-13DB-7F83F0AD611E}"/>
              </a:ext>
            </a:extLst>
          </p:cNvPr>
          <p:cNvSpPr txBox="1"/>
          <p:nvPr/>
        </p:nvSpPr>
        <p:spPr>
          <a:xfrm>
            <a:off x="149811" y="3220726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400"/>
              <a:t>C</a:t>
            </a:r>
          </a:p>
        </p:txBody>
      </p:sp>
      <p:grpSp>
        <p:nvGrpSpPr>
          <p:cNvPr id="15" name="Csoportba foglalás 14">
            <a:extLst>
              <a:ext uri="{FF2B5EF4-FFF2-40B4-BE49-F238E27FC236}">
                <a16:creationId xmlns:a16="http://schemas.microsoft.com/office/drawing/2014/main" id="{05A61178-14C9-E902-C72F-7EB819DFB682}"/>
              </a:ext>
            </a:extLst>
          </p:cNvPr>
          <p:cNvGrpSpPr/>
          <p:nvPr/>
        </p:nvGrpSpPr>
        <p:grpSpPr>
          <a:xfrm>
            <a:off x="656696" y="3251664"/>
            <a:ext cx="3547476" cy="3252044"/>
            <a:chOff x="512411" y="3308295"/>
            <a:chExt cx="3547476" cy="3252044"/>
          </a:xfrm>
        </p:grpSpPr>
        <p:grpSp>
          <p:nvGrpSpPr>
            <p:cNvPr id="13" name="Csoportba foglalás 12">
              <a:extLst>
                <a:ext uri="{FF2B5EF4-FFF2-40B4-BE49-F238E27FC236}">
                  <a16:creationId xmlns:a16="http://schemas.microsoft.com/office/drawing/2014/main" id="{9130541A-EEA0-AE9A-CE08-47928C6B28BF}"/>
                </a:ext>
              </a:extLst>
            </p:cNvPr>
            <p:cNvGrpSpPr/>
            <p:nvPr/>
          </p:nvGrpSpPr>
          <p:grpSpPr>
            <a:xfrm>
              <a:off x="517596" y="3308295"/>
              <a:ext cx="3542291" cy="3252044"/>
              <a:chOff x="517596" y="3308295"/>
              <a:chExt cx="3542291" cy="3252044"/>
            </a:xfrm>
          </p:grpSpPr>
          <p:pic>
            <p:nvPicPr>
              <p:cNvPr id="4" name="Kép 3">
                <a:extLst>
                  <a:ext uri="{FF2B5EF4-FFF2-40B4-BE49-F238E27FC236}">
                    <a16:creationId xmlns:a16="http://schemas.microsoft.com/office/drawing/2014/main" id="{E9C64AB2-F220-7DA3-4EE4-F9D3DF8C622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160395" y="3339596"/>
                <a:ext cx="2899492" cy="3189442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11" name="Szövegdoboz 10">
                <a:extLst>
                  <a:ext uri="{FF2B5EF4-FFF2-40B4-BE49-F238E27FC236}">
                    <a16:creationId xmlns:a16="http://schemas.microsoft.com/office/drawing/2014/main" id="{5BF33F5B-B019-2E10-137E-CC0AB6A9CECE}"/>
                  </a:ext>
                </a:extLst>
              </p:cNvPr>
              <p:cNvSpPr txBox="1"/>
              <p:nvPr/>
            </p:nvSpPr>
            <p:spPr>
              <a:xfrm>
                <a:off x="517596" y="3308295"/>
                <a:ext cx="679994" cy="32520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1300"/>
                  </a:lnSpc>
                </a:pPr>
                <a:r>
                  <a:rPr lang="hu-HU" sz="1000"/>
                  <a:t>AtPAO1</a:t>
                </a:r>
              </a:p>
              <a:p>
                <a:pPr>
                  <a:lnSpc>
                    <a:spcPts val="1300"/>
                  </a:lnSpc>
                </a:pPr>
                <a:r>
                  <a:rPr lang="hu-HU" sz="1000"/>
                  <a:t>NtPAO1A</a:t>
                </a:r>
              </a:p>
              <a:p>
                <a:pPr>
                  <a:lnSpc>
                    <a:spcPts val="1300"/>
                  </a:lnSpc>
                </a:pPr>
                <a:r>
                  <a:rPr lang="hu-HU" sz="1000"/>
                  <a:t>NtPAO1B</a:t>
                </a:r>
              </a:p>
              <a:p>
                <a:pPr>
                  <a:lnSpc>
                    <a:spcPts val="1300"/>
                  </a:lnSpc>
                </a:pPr>
                <a:r>
                  <a:rPr lang="hu-HU" sz="1000"/>
                  <a:t>AtPAOP5</a:t>
                </a:r>
              </a:p>
              <a:p>
                <a:pPr>
                  <a:lnSpc>
                    <a:spcPts val="1300"/>
                  </a:lnSpc>
                </a:pPr>
                <a:r>
                  <a:rPr lang="hu-HU" sz="1000"/>
                  <a:t>NtPAO5A</a:t>
                </a:r>
              </a:p>
              <a:p>
                <a:pPr>
                  <a:lnSpc>
                    <a:spcPts val="1300"/>
                  </a:lnSpc>
                </a:pPr>
                <a:r>
                  <a:rPr lang="hu-HU" sz="1000"/>
                  <a:t>NtPAO5B</a:t>
                </a:r>
              </a:p>
              <a:p>
                <a:pPr>
                  <a:lnSpc>
                    <a:spcPts val="1300"/>
                  </a:lnSpc>
                </a:pPr>
                <a:r>
                  <a:rPr lang="hu-HU" sz="1000"/>
                  <a:t>NtPAO5C</a:t>
                </a:r>
              </a:p>
              <a:p>
                <a:pPr>
                  <a:lnSpc>
                    <a:spcPts val="1300"/>
                  </a:lnSpc>
                </a:pPr>
                <a:r>
                  <a:rPr lang="hu-HU" sz="1000"/>
                  <a:t>NtPAO5D</a:t>
                </a:r>
              </a:p>
              <a:p>
                <a:pPr>
                  <a:lnSpc>
                    <a:spcPts val="1300"/>
                  </a:lnSpc>
                </a:pPr>
                <a:r>
                  <a:rPr lang="hu-HU" sz="1000"/>
                  <a:t>NtPAO5E</a:t>
                </a:r>
              </a:p>
              <a:p>
                <a:pPr>
                  <a:lnSpc>
                    <a:spcPts val="1300"/>
                  </a:lnSpc>
                </a:pPr>
                <a:r>
                  <a:rPr lang="hu-HU" sz="1000"/>
                  <a:t>AtPAO2</a:t>
                </a:r>
              </a:p>
              <a:p>
                <a:pPr>
                  <a:lnSpc>
                    <a:spcPts val="1300"/>
                  </a:lnSpc>
                </a:pPr>
                <a:r>
                  <a:rPr lang="hu-HU" sz="1000"/>
                  <a:t>AtPAO3</a:t>
                </a:r>
              </a:p>
              <a:p>
                <a:pPr>
                  <a:lnSpc>
                    <a:spcPts val="1300"/>
                  </a:lnSpc>
                </a:pPr>
                <a:r>
                  <a:rPr lang="hu-HU" sz="1000"/>
                  <a:t>NtPAO2A</a:t>
                </a:r>
              </a:p>
              <a:p>
                <a:pPr>
                  <a:lnSpc>
                    <a:spcPts val="1300"/>
                  </a:lnSpc>
                </a:pPr>
                <a:r>
                  <a:rPr lang="hu-HU" sz="1000"/>
                  <a:t>NtPAO2B</a:t>
                </a:r>
              </a:p>
              <a:p>
                <a:pPr>
                  <a:lnSpc>
                    <a:spcPts val="1300"/>
                  </a:lnSpc>
                </a:pPr>
                <a:r>
                  <a:rPr lang="hu-HU" sz="1000"/>
                  <a:t>NtPAO2C</a:t>
                </a:r>
              </a:p>
              <a:p>
                <a:pPr>
                  <a:lnSpc>
                    <a:spcPts val="1300"/>
                  </a:lnSpc>
                </a:pPr>
                <a:r>
                  <a:rPr lang="hu-HU" sz="1000"/>
                  <a:t>AtPAO4</a:t>
                </a:r>
              </a:p>
              <a:p>
                <a:pPr>
                  <a:lnSpc>
                    <a:spcPts val="1300"/>
                  </a:lnSpc>
                </a:pPr>
                <a:r>
                  <a:rPr lang="hu-HU" sz="1000"/>
                  <a:t>NtPAO4A</a:t>
                </a:r>
              </a:p>
              <a:p>
                <a:pPr>
                  <a:lnSpc>
                    <a:spcPts val="1300"/>
                  </a:lnSpc>
                </a:pPr>
                <a:r>
                  <a:rPr lang="hu-HU" sz="1000"/>
                  <a:t>NtPAO4B</a:t>
                </a:r>
              </a:p>
              <a:p>
                <a:pPr>
                  <a:lnSpc>
                    <a:spcPts val="1300"/>
                  </a:lnSpc>
                </a:pPr>
                <a:r>
                  <a:rPr lang="hu-HU" sz="1000"/>
                  <a:t>NtPAO4C</a:t>
                </a:r>
              </a:p>
              <a:p>
                <a:pPr>
                  <a:lnSpc>
                    <a:spcPts val="1300"/>
                  </a:lnSpc>
                </a:pPr>
                <a:r>
                  <a:rPr lang="hu-HU" sz="1000"/>
                  <a:t>NtPAO4D</a:t>
                </a:r>
              </a:p>
            </p:txBody>
          </p:sp>
        </p:grpSp>
        <p:sp>
          <p:nvSpPr>
            <p:cNvPr id="14" name="Téglalap 13">
              <a:extLst>
                <a:ext uri="{FF2B5EF4-FFF2-40B4-BE49-F238E27FC236}">
                  <a16:creationId xmlns:a16="http://schemas.microsoft.com/office/drawing/2014/main" id="{CBF1CD14-ABE3-4079-0495-27813560D6AE}"/>
                </a:ext>
              </a:extLst>
            </p:cNvPr>
            <p:cNvSpPr/>
            <p:nvPr/>
          </p:nvSpPr>
          <p:spPr>
            <a:xfrm>
              <a:off x="512411" y="3339596"/>
              <a:ext cx="3547476" cy="3189442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</p:grpSp>
    </p:spTree>
    <p:extLst>
      <p:ext uri="{BB962C8B-B14F-4D97-AF65-F5344CB8AC3E}">
        <p14:creationId xmlns:p14="http://schemas.microsoft.com/office/powerpoint/2010/main" val="1544474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0</TotalTime>
  <Words>134</Words>
  <Application>Microsoft Office PowerPoint</Application>
  <PresentationFormat>Szélesvásznú</PresentationFormat>
  <Paragraphs>23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Fehér Attila Dr.</dc:creator>
  <cp:lastModifiedBy>Fehér Attila Dr.</cp:lastModifiedBy>
  <cp:revision>4</cp:revision>
  <dcterms:created xsi:type="dcterms:W3CDTF">2023-10-16T10:54:05Z</dcterms:created>
  <dcterms:modified xsi:type="dcterms:W3CDTF">2023-10-29T16:55:18Z</dcterms:modified>
</cp:coreProperties>
</file>